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0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0" autoAdjust="0"/>
    <p:restoredTop sz="94633"/>
  </p:normalViewPr>
  <p:slideViewPr>
    <p:cSldViewPr snapToGrid="0" snapToObjects="1">
      <p:cViewPr varScale="1">
        <p:scale>
          <a:sx n="80" d="100"/>
          <a:sy n="80" d="100"/>
        </p:scale>
        <p:origin x="2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PF2;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8:$K$88</c:f>
                <c:numCache>
                  <c:formatCode>General</c:formatCode>
                  <c:ptCount val="2"/>
                  <c:pt idx="0">
                    <c:v>0.39429054482934933</c:v>
                  </c:pt>
                  <c:pt idx="1">
                    <c:v>0.14743939970827813</c:v>
                  </c:pt>
                </c:numCache>
              </c:numRef>
            </c:plus>
            <c:minus>
              <c:numRef>
                <c:f>log2じゃない方!$J$88:$K$88</c:f>
                <c:numCache>
                  <c:formatCode>General</c:formatCode>
                  <c:ptCount val="2"/>
                  <c:pt idx="0">
                    <c:v>0.39429054482934933</c:v>
                  </c:pt>
                  <c:pt idx="1">
                    <c:v>0.147439399708278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8:$I$88</c:f>
              <c:numCache>
                <c:formatCode>General</c:formatCode>
                <c:ptCount val="2"/>
                <c:pt idx="0">
                  <c:v>1.3747185418469365</c:v>
                </c:pt>
                <c:pt idx="1">
                  <c:v>0.620957299152674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29-4EE9-B3E6-CF3309B5B7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CC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2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9:$K$89</c:f>
                <c:numCache>
                  <c:formatCode>General</c:formatCode>
                  <c:ptCount val="2"/>
                  <c:pt idx="0">
                    <c:v>4.0653139950995412E-2</c:v>
                  </c:pt>
                  <c:pt idx="1">
                    <c:v>5.4693543583487055E-2</c:v>
                  </c:pt>
                </c:numCache>
              </c:numRef>
            </c:plus>
            <c:minus>
              <c:numRef>
                <c:f>log2じゃない方!$J$89:$K$89</c:f>
                <c:numCache>
                  <c:formatCode>General</c:formatCode>
                  <c:ptCount val="2"/>
                  <c:pt idx="0">
                    <c:v>4.0653139950995412E-2</c:v>
                  </c:pt>
                  <c:pt idx="1">
                    <c:v>5.469354358348705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9:$I$89</c:f>
              <c:numCache>
                <c:formatCode>General</c:formatCode>
                <c:ptCount val="2"/>
                <c:pt idx="0">
                  <c:v>0.53226807282285149</c:v>
                </c:pt>
                <c:pt idx="1">
                  <c:v>0.555872185203728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2C-4DEB-889F-B8DCAB6931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LC6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5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92:$K$92</c:f>
                <c:numCache>
                  <c:formatCode>General</c:formatCode>
                  <c:ptCount val="2"/>
                  <c:pt idx="0">
                    <c:v>0.3941827468065861</c:v>
                  </c:pt>
                  <c:pt idx="1">
                    <c:v>0.15201276542203121</c:v>
                  </c:pt>
                </c:numCache>
              </c:numRef>
            </c:plus>
            <c:minus>
              <c:numRef>
                <c:f>log2じゃない方!$J$92:$K$92</c:f>
                <c:numCache>
                  <c:formatCode>General</c:formatCode>
                  <c:ptCount val="2"/>
                  <c:pt idx="0">
                    <c:v>0.3941827468065861</c:v>
                  </c:pt>
                  <c:pt idx="1">
                    <c:v>0.152012765422031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92:$I$92</c:f>
              <c:numCache>
                <c:formatCode>General</c:formatCode>
                <c:ptCount val="2"/>
                <c:pt idx="0">
                  <c:v>1.8691267944438164</c:v>
                </c:pt>
                <c:pt idx="1">
                  <c:v>0.914663543789869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BB-462C-9D7C-96D10C03B3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LC5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91:$K$91</c:f>
                <c:numCache>
                  <c:formatCode>General</c:formatCode>
                  <c:ptCount val="2"/>
                  <c:pt idx="0">
                    <c:v>0.18124210915180852</c:v>
                  </c:pt>
                  <c:pt idx="1">
                    <c:v>0.27102861074719042</c:v>
                  </c:pt>
                </c:numCache>
              </c:numRef>
            </c:plus>
            <c:minus>
              <c:numRef>
                <c:f>log2じゃない方!$J$91:$K$91</c:f>
                <c:numCache>
                  <c:formatCode>General</c:formatCode>
                  <c:ptCount val="2"/>
                  <c:pt idx="0">
                    <c:v>0.18124210915180852</c:v>
                  </c:pt>
                  <c:pt idx="1">
                    <c:v>0.271028610747190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91:$I$91</c:f>
              <c:numCache>
                <c:formatCode>General</c:formatCode>
                <c:ptCount val="2"/>
                <c:pt idx="0">
                  <c:v>0.93266494474047479</c:v>
                </c:pt>
                <c:pt idx="1">
                  <c:v>0.910436450015439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C7C-477B-94A2-786DFE095A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LC2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3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90:$K$90</c:f>
                <c:numCache>
                  <c:formatCode>General</c:formatCode>
                  <c:ptCount val="2"/>
                  <c:pt idx="0">
                    <c:v>0.12932878042167167</c:v>
                  </c:pt>
                  <c:pt idx="1">
                    <c:v>4.4381574590884099E-2</c:v>
                  </c:pt>
                </c:numCache>
              </c:numRef>
            </c:plus>
            <c:minus>
              <c:numRef>
                <c:f>log2じゃない方!$J$90:$K$90</c:f>
                <c:numCache>
                  <c:formatCode>General</c:formatCode>
                  <c:ptCount val="2"/>
                  <c:pt idx="0">
                    <c:v>0.12932878042167167</c:v>
                  </c:pt>
                  <c:pt idx="1">
                    <c:v>4.43815745908840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90:$I$90</c:f>
              <c:numCache>
                <c:formatCode>General</c:formatCode>
                <c:ptCount val="2"/>
                <c:pt idx="0">
                  <c:v>0.91615843496527616</c:v>
                </c:pt>
                <c:pt idx="1">
                  <c:v>0.404446849978155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95-4191-A230-B0ACC5B0D2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SLAH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6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93:$K$93</c:f>
                <c:numCache>
                  <c:formatCode>General</c:formatCode>
                  <c:ptCount val="2"/>
                  <c:pt idx="0">
                    <c:v>4.7841368053514969E-3</c:v>
                  </c:pt>
                  <c:pt idx="1">
                    <c:v>5.9552381765171098E-3</c:v>
                  </c:pt>
                </c:numCache>
              </c:numRef>
            </c:plus>
            <c:minus>
              <c:numRef>
                <c:f>log2じゃない方!$J$93:$K$93</c:f>
                <c:numCache>
                  <c:formatCode>General</c:formatCode>
                  <c:ptCount val="2"/>
                  <c:pt idx="0">
                    <c:v>4.7841368053514969E-3</c:v>
                  </c:pt>
                  <c:pt idx="1">
                    <c:v>5.95523817651710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93:$I$93</c:f>
              <c:numCache>
                <c:formatCode>General</c:formatCode>
                <c:ptCount val="2"/>
                <c:pt idx="0">
                  <c:v>2.3118419688732978E-2</c:v>
                </c:pt>
                <c:pt idx="1">
                  <c:v>6.18637290983971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017-4150-9A3C-1AB9A9DFDE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SLAH7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94:$K$94</c:f>
                <c:numCache>
                  <c:formatCode>General</c:formatCode>
                  <c:ptCount val="2"/>
                  <c:pt idx="0">
                    <c:v>2.2223615958645478E-3</c:v>
                  </c:pt>
                  <c:pt idx="1">
                    <c:v>4.2079029803573649E-4</c:v>
                  </c:pt>
                </c:numCache>
              </c:numRef>
            </c:plus>
            <c:minus>
              <c:numRef>
                <c:f>log2じゃない方!$J$94:$K$94</c:f>
                <c:numCache>
                  <c:formatCode>General</c:formatCode>
                  <c:ptCount val="2"/>
                  <c:pt idx="0">
                    <c:v>2.2223615958645478E-3</c:v>
                  </c:pt>
                  <c:pt idx="1">
                    <c:v>4.2079029803573649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94:$I$94</c:f>
              <c:numCache>
                <c:formatCode>General</c:formatCode>
                <c:ptCount val="2"/>
                <c:pt idx="0">
                  <c:v>1.4647400091188758E-2</c:v>
                </c:pt>
                <c:pt idx="1">
                  <c:v>1.890535222953589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AF-4891-B7B8-A2E3C40BF2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9980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55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1143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142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5772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23528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953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500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63792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37358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1867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7373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0729FF91-817D-4956-AB86-C3D40558973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0407106"/>
              </p:ext>
            </p:extLst>
          </p:nvPr>
        </p:nvGraphicFramePr>
        <p:xfrm>
          <a:off x="732313" y="896681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28211002-A517-4861-B8B4-5D64D8A321D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5363252"/>
              </p:ext>
            </p:extLst>
          </p:nvPr>
        </p:nvGraphicFramePr>
        <p:xfrm>
          <a:off x="2715079" y="894782"/>
          <a:ext cx="1930422" cy="14178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55F7F92D-178C-4412-A19F-E573EBE70C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9653954"/>
              </p:ext>
            </p:extLst>
          </p:nvPr>
        </p:nvGraphicFramePr>
        <p:xfrm>
          <a:off x="2715079" y="2359101"/>
          <a:ext cx="1938286" cy="14178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40537D2B-0A37-462D-9015-E73BA41A23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6759266"/>
              </p:ext>
            </p:extLst>
          </p:nvPr>
        </p:nvGraphicFramePr>
        <p:xfrm>
          <a:off x="732314" y="2368640"/>
          <a:ext cx="1930423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9D945B22-7159-46FC-8B23-256003EE55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5217406"/>
              </p:ext>
            </p:extLst>
          </p:nvPr>
        </p:nvGraphicFramePr>
        <p:xfrm>
          <a:off x="4705707" y="894782"/>
          <a:ext cx="1930423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15502300-6753-4B51-9F28-7C71D05C6E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9795791"/>
              </p:ext>
            </p:extLst>
          </p:nvPr>
        </p:nvGraphicFramePr>
        <p:xfrm>
          <a:off x="4705706" y="2353295"/>
          <a:ext cx="1930423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92F3981B-8A6B-41DF-9DA8-EA03DC45CC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6975049"/>
              </p:ext>
            </p:extLst>
          </p:nvPr>
        </p:nvGraphicFramePr>
        <p:xfrm>
          <a:off x="730385" y="3836406"/>
          <a:ext cx="1930423" cy="14178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82B96BC-3358-41F0-84FB-4B486038E30F}"/>
              </a:ext>
            </a:extLst>
          </p:cNvPr>
          <p:cNvSpPr txBox="1"/>
          <p:nvPr/>
        </p:nvSpPr>
        <p:spPr>
          <a:xfrm>
            <a:off x="5280115" y="1357321"/>
            <a:ext cx="2573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067B13-0ECA-4843-A6F7-067E2D49CB4D}"/>
              </a:ext>
            </a:extLst>
          </p:cNvPr>
          <p:cNvSpPr txBox="1"/>
          <p:nvPr/>
        </p:nvSpPr>
        <p:spPr>
          <a:xfrm>
            <a:off x="6019319" y="2697954"/>
            <a:ext cx="25733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BD4F5DD-9933-CB41-A50F-F6AA85103ABF}"/>
              </a:ext>
            </a:extLst>
          </p:cNvPr>
          <p:cNvSpPr txBox="1"/>
          <p:nvPr/>
        </p:nvSpPr>
        <p:spPr>
          <a:xfrm>
            <a:off x="730385" y="894783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9CDF6AF-20AA-D242-ADED-DD0E692F8B91}"/>
              </a:ext>
            </a:extLst>
          </p:cNvPr>
          <p:cNvSpPr txBox="1"/>
          <p:nvPr/>
        </p:nvSpPr>
        <p:spPr>
          <a:xfrm>
            <a:off x="2708620" y="894783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57763AA-1F40-CA49-BB6C-FDB5A22BB45A}"/>
              </a:ext>
            </a:extLst>
          </p:cNvPr>
          <p:cNvSpPr txBox="1"/>
          <p:nvPr/>
        </p:nvSpPr>
        <p:spPr>
          <a:xfrm>
            <a:off x="4707417" y="894782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5C0183E-1C25-E04A-86C7-666E2216AAEC}"/>
              </a:ext>
            </a:extLst>
          </p:cNvPr>
          <p:cNvSpPr txBox="1"/>
          <p:nvPr/>
        </p:nvSpPr>
        <p:spPr>
          <a:xfrm>
            <a:off x="730385" y="2370843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FAC84F5-7190-F34A-AFEB-1510B8BE7ABE}"/>
              </a:ext>
            </a:extLst>
          </p:cNvPr>
          <p:cNvSpPr txBox="1"/>
          <p:nvPr/>
        </p:nvSpPr>
        <p:spPr>
          <a:xfrm>
            <a:off x="2707045" y="2350820"/>
            <a:ext cx="26321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BF13A3A-E6F6-8543-BBD0-E0197D163E51}"/>
              </a:ext>
            </a:extLst>
          </p:cNvPr>
          <p:cNvSpPr txBox="1"/>
          <p:nvPr/>
        </p:nvSpPr>
        <p:spPr>
          <a:xfrm>
            <a:off x="4707557" y="2350820"/>
            <a:ext cx="25519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D0978FB-895D-364D-B6EA-FBC10910A038}"/>
              </a:ext>
            </a:extLst>
          </p:cNvPr>
          <p:cNvSpPr txBox="1"/>
          <p:nvPr/>
        </p:nvSpPr>
        <p:spPr>
          <a:xfrm>
            <a:off x="730385" y="3849431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26" name="Text Box 30">
            <a:extLst>
              <a:ext uri="{FF2B5EF4-FFF2-40B4-BE49-F238E27FC236}">
                <a16:creationId xmlns:a16="http://schemas.microsoft.com/office/drawing/2014/main" id="{36475300-1F91-8A47-A537-667A77098532}"/>
              </a:ext>
            </a:extLst>
          </p:cNvPr>
          <p:cNvSpPr txBox="1"/>
          <p:nvPr/>
        </p:nvSpPr>
        <p:spPr>
          <a:xfrm rot="16200000">
            <a:off x="-719401" y="2805780"/>
            <a:ext cx="2631440" cy="37237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132080" tIns="66040" rIns="132080" bIns="6604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JP" sz="1200" dirty="0"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Relative expression level</a:t>
            </a:r>
            <a:endParaRPr lang="en-JP" sz="1400" dirty="0"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8" name="テキスト ボックス 34">
            <a:extLst>
              <a:ext uri="{FF2B5EF4-FFF2-40B4-BE49-F238E27FC236}">
                <a16:creationId xmlns:a16="http://schemas.microsoft.com/office/drawing/2014/main" id="{26F8480B-CC75-9F4B-BA09-6F1D9ADE2E25}"/>
              </a:ext>
            </a:extLst>
          </p:cNvPr>
          <p:cNvSpPr txBox="1"/>
          <p:nvPr/>
        </p:nvSpPr>
        <p:spPr>
          <a:xfrm>
            <a:off x="1161547" y="202935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34">
            <a:extLst>
              <a:ext uri="{FF2B5EF4-FFF2-40B4-BE49-F238E27FC236}">
                <a16:creationId xmlns:a16="http://schemas.microsoft.com/office/drawing/2014/main" id="{5AEFEC40-4DF8-494A-B2BC-96D9FEDF9F34}"/>
              </a:ext>
            </a:extLst>
          </p:cNvPr>
          <p:cNvSpPr txBox="1"/>
          <p:nvPr/>
        </p:nvSpPr>
        <p:spPr>
          <a:xfrm>
            <a:off x="1161547" y="3494915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34">
            <a:extLst>
              <a:ext uri="{FF2B5EF4-FFF2-40B4-BE49-F238E27FC236}">
                <a16:creationId xmlns:a16="http://schemas.microsoft.com/office/drawing/2014/main" id="{2449E7E5-288D-6C42-93E5-6368F2300815}"/>
              </a:ext>
            </a:extLst>
          </p:cNvPr>
          <p:cNvSpPr txBox="1"/>
          <p:nvPr/>
        </p:nvSpPr>
        <p:spPr>
          <a:xfrm>
            <a:off x="1161547" y="4960478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4">
            <a:extLst>
              <a:ext uri="{FF2B5EF4-FFF2-40B4-BE49-F238E27FC236}">
                <a16:creationId xmlns:a16="http://schemas.microsoft.com/office/drawing/2014/main" id="{88E3A42B-8FC1-684E-8BC6-3BFAACAB75B8}"/>
              </a:ext>
            </a:extLst>
          </p:cNvPr>
          <p:cNvSpPr txBox="1"/>
          <p:nvPr/>
        </p:nvSpPr>
        <p:spPr>
          <a:xfrm>
            <a:off x="3154471" y="202935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4">
            <a:extLst>
              <a:ext uri="{FF2B5EF4-FFF2-40B4-BE49-F238E27FC236}">
                <a16:creationId xmlns:a16="http://schemas.microsoft.com/office/drawing/2014/main" id="{9837169D-ED5D-3143-93EF-569FDF9139CF}"/>
              </a:ext>
            </a:extLst>
          </p:cNvPr>
          <p:cNvSpPr txBox="1"/>
          <p:nvPr/>
        </p:nvSpPr>
        <p:spPr>
          <a:xfrm>
            <a:off x="5127447" y="202935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4">
            <a:extLst>
              <a:ext uri="{FF2B5EF4-FFF2-40B4-BE49-F238E27FC236}">
                <a16:creationId xmlns:a16="http://schemas.microsoft.com/office/drawing/2014/main" id="{BC9C1E20-9B7C-0B4E-A673-D71D10608129}"/>
              </a:ext>
            </a:extLst>
          </p:cNvPr>
          <p:cNvSpPr txBox="1"/>
          <p:nvPr/>
        </p:nvSpPr>
        <p:spPr>
          <a:xfrm>
            <a:off x="3154471" y="3494915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4">
            <a:extLst>
              <a:ext uri="{FF2B5EF4-FFF2-40B4-BE49-F238E27FC236}">
                <a16:creationId xmlns:a16="http://schemas.microsoft.com/office/drawing/2014/main" id="{3BCC6703-1742-704D-9726-B30CFC0555B8}"/>
              </a:ext>
            </a:extLst>
          </p:cNvPr>
          <p:cNvSpPr txBox="1"/>
          <p:nvPr/>
        </p:nvSpPr>
        <p:spPr>
          <a:xfrm>
            <a:off x="5127447" y="3487865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7569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0</TotalTime>
  <Words>33</Words>
  <Application>Microsoft Office PowerPoint</Application>
  <PresentationFormat>A4 210 x 297 mm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90</cp:revision>
  <cp:lastPrinted>2020-08-12T07:18:28Z</cp:lastPrinted>
  <dcterms:created xsi:type="dcterms:W3CDTF">2020-05-19T13:06:08Z</dcterms:created>
  <dcterms:modified xsi:type="dcterms:W3CDTF">2020-08-13T07:27:37Z</dcterms:modified>
</cp:coreProperties>
</file>